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440" r:id="rId2"/>
  </p:sldIdLst>
  <p:sldSz cx="6858000" cy="9906000" type="A4"/>
  <p:notesSz cx="6797675" cy="9926638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Bonz" initials="B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99FF99"/>
    <a:srgbClr val="FFCCFF"/>
    <a:srgbClr val="0000FF"/>
    <a:srgbClr val="FF66FF"/>
    <a:srgbClr val="00FF00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4564" autoAdjust="0"/>
    <p:restoredTop sz="94660"/>
  </p:normalViewPr>
  <p:slideViewPr>
    <p:cSldViewPr snapToGrid="0">
      <p:cViewPr varScale="1">
        <p:scale>
          <a:sx n="68" d="100"/>
          <a:sy n="68" d="100"/>
        </p:scale>
        <p:origin x="528" y="57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1" y="0"/>
            <a:ext cx="2945659" cy="496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312" tIns="45656" rIns="91312" bIns="45656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/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50443" y="0"/>
            <a:ext cx="2945659" cy="496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312" tIns="45656" rIns="91312" bIns="45656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endParaRPr lang="en-US" altLang="ja-JP"/>
          </a:p>
        </p:txBody>
      </p:sp>
      <p:sp>
        <p:nvSpPr>
          <p:cNvPr id="307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111375" y="744538"/>
            <a:ext cx="2574925" cy="37211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3077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9768" y="4715153"/>
            <a:ext cx="5438140" cy="44669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312" tIns="45656" rIns="91312" bIns="45656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3078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1" y="9428584"/>
            <a:ext cx="2945659" cy="496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312" tIns="45656" rIns="91312" bIns="45656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/>
          </a:p>
        </p:txBody>
      </p:sp>
      <p:sp>
        <p:nvSpPr>
          <p:cNvPr id="3079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50443" y="9428584"/>
            <a:ext cx="2945659" cy="496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312" tIns="45656" rIns="91312" bIns="45656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8D4352E6-89F8-4665-AABB-9BFB301042BF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28975009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218A52F-AD42-41C8-AC48-CB1B906BFC49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413042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E3BD49A-75D7-4723-A655-57CFFCB46F1F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550523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185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185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8C33628-4CC6-4D54-8BC2-3DBF802F5BEF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731713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4482557-481C-457D-BE70-B64C37DBA84A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004063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011A67C-E722-4B2E-B0D5-98A6C380816B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966845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028FB93-0856-4DC4-A2A3-DEF36F6FC7A8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27668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BCB2924-FB0E-4717-9FFC-B45B7CE5D586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821176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DD52CF7-C59C-46A7-B7A9-B827D4CD9320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391210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1F7A3AE-4DF2-4C09-A987-5AF06D3A1956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47325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AF329C4-52D5-4A2F-879E-DAAFDB9BC19B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238769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EEFB6BD-4970-4287-A8F6-8A972207E212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453380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9020175"/>
            <a:ext cx="1600200" cy="688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en-US" altLang="ja-JP">
              <a:solidFill>
                <a:srgbClr val="000000"/>
              </a:solidFill>
              <a:ea typeface="ＭＳ Ｐゴシック" charset="-128"/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0175"/>
            <a:ext cx="2171700" cy="688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en-US" altLang="ja-JP">
              <a:solidFill>
                <a:srgbClr val="000000"/>
              </a:solidFill>
              <a:ea typeface="ＭＳ Ｐゴシック" charset="-128"/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0175"/>
            <a:ext cx="1600200" cy="688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EE8B3270-0423-456C-9A24-B578D10E50EE}" type="slidenum">
              <a:rPr lang="en-US" altLang="ja-JP" smtClean="0">
                <a:solidFill>
                  <a:srgbClr val="000000"/>
                </a:solidFill>
                <a:ea typeface="ＭＳ Ｐゴシック" charset="-128"/>
              </a:rPr>
              <a:pPr/>
              <a:t>‹#›</a:t>
            </a:fld>
            <a:endParaRPr lang="en-US" altLang="ja-JP">
              <a:solidFill>
                <a:srgbClr val="000000"/>
              </a:solidFill>
              <a:ea typeface="ＭＳ Ｐゴシック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4765896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2pPr>
      <a:lvl3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3pPr>
      <a:lvl4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4pPr>
      <a:lvl5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/>
          <p:cNvSpPr/>
          <p:nvPr/>
        </p:nvSpPr>
        <p:spPr>
          <a:xfrm>
            <a:off x="3943350" y="69011"/>
            <a:ext cx="2805381" cy="44282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Table 2</a:t>
            </a:r>
            <a:endParaRPr kumimoji="1" lang="ja-JP" altLang="en-US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表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81137627"/>
              </p:ext>
            </p:extLst>
          </p:nvPr>
        </p:nvGraphicFramePr>
        <p:xfrm>
          <a:off x="142875" y="1281747"/>
          <a:ext cx="6561175" cy="467615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49263">
                  <a:extLst>
                    <a:ext uri="{9D8B030D-6E8A-4147-A177-3AD203B41FA5}">
                      <a16:colId xmlns:a16="http://schemas.microsoft.com/office/drawing/2014/main" val="3713842460"/>
                    </a:ext>
                  </a:extLst>
                </a:gridCol>
                <a:gridCol w="756971">
                  <a:extLst>
                    <a:ext uri="{9D8B030D-6E8A-4147-A177-3AD203B41FA5}">
                      <a16:colId xmlns:a16="http://schemas.microsoft.com/office/drawing/2014/main" val="2963044056"/>
                    </a:ext>
                  </a:extLst>
                </a:gridCol>
                <a:gridCol w="756971">
                  <a:extLst>
                    <a:ext uri="{9D8B030D-6E8A-4147-A177-3AD203B41FA5}">
                      <a16:colId xmlns:a16="http://schemas.microsoft.com/office/drawing/2014/main" val="3421396816"/>
                    </a:ext>
                  </a:extLst>
                </a:gridCol>
                <a:gridCol w="755035">
                  <a:extLst>
                    <a:ext uri="{9D8B030D-6E8A-4147-A177-3AD203B41FA5}">
                      <a16:colId xmlns:a16="http://schemas.microsoft.com/office/drawing/2014/main" val="1826968123"/>
                    </a:ext>
                  </a:extLst>
                </a:gridCol>
                <a:gridCol w="787947">
                  <a:extLst>
                    <a:ext uri="{9D8B030D-6E8A-4147-A177-3AD203B41FA5}">
                      <a16:colId xmlns:a16="http://schemas.microsoft.com/office/drawing/2014/main" val="3807776193"/>
                    </a:ext>
                  </a:extLst>
                </a:gridCol>
                <a:gridCol w="755035">
                  <a:extLst>
                    <a:ext uri="{9D8B030D-6E8A-4147-A177-3AD203B41FA5}">
                      <a16:colId xmlns:a16="http://schemas.microsoft.com/office/drawing/2014/main" val="34831493"/>
                    </a:ext>
                  </a:extLst>
                </a:gridCol>
                <a:gridCol w="787947">
                  <a:extLst>
                    <a:ext uri="{9D8B030D-6E8A-4147-A177-3AD203B41FA5}">
                      <a16:colId xmlns:a16="http://schemas.microsoft.com/office/drawing/2014/main" val="696982643"/>
                    </a:ext>
                  </a:extLst>
                </a:gridCol>
                <a:gridCol w="755035">
                  <a:extLst>
                    <a:ext uri="{9D8B030D-6E8A-4147-A177-3AD203B41FA5}">
                      <a16:colId xmlns:a16="http://schemas.microsoft.com/office/drawing/2014/main" val="1966244489"/>
                    </a:ext>
                  </a:extLst>
                </a:gridCol>
                <a:gridCol w="756971">
                  <a:extLst>
                    <a:ext uri="{9D8B030D-6E8A-4147-A177-3AD203B41FA5}">
                      <a16:colId xmlns:a16="http://schemas.microsoft.com/office/drawing/2014/main" val="991812291"/>
                    </a:ext>
                  </a:extLst>
                </a:gridCol>
              </a:tblGrid>
              <a:tr h="143973">
                <a:tc>
                  <a:txBody>
                    <a:bodyPr/>
                    <a:lstStyle/>
                    <a:p>
                      <a:pPr algn="l" fontAlgn="ctr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ft 4 cm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ft 2 cm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ght 2 cm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ght 4 cm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40146768"/>
                  </a:ext>
                </a:extLst>
              </a:tr>
              <a:tr h="111979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69971856"/>
                  </a:ext>
                </a:extLst>
              </a:tr>
              <a:tr h="111979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34" charset="-128"/>
                          <a:cs typeface="Arial" panose="020B0604020202020204" pitchFamily="34" charset="0"/>
                        </a:rPr>
                        <a:t>Before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34" charset="-128"/>
                          <a:cs typeface="Arial" panose="020B0604020202020204" pitchFamily="34" charset="0"/>
                        </a:rPr>
                        <a:t>CTR</a:t>
                      </a: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34" charset="-128"/>
                          <a:cs typeface="Arial" panose="020B0604020202020204" pitchFamily="34" charset="0"/>
                        </a:rPr>
                        <a:t>LC</a:t>
                      </a: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34" charset="-128"/>
                          <a:cs typeface="Arial" panose="020B0604020202020204" pitchFamily="34" charset="0"/>
                        </a:rPr>
                        <a:t>CTR</a:t>
                      </a: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34" charset="-128"/>
                          <a:cs typeface="Arial" panose="020B0604020202020204" pitchFamily="34" charset="0"/>
                        </a:rPr>
                        <a:t>LC</a:t>
                      </a: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34" charset="-128"/>
                          <a:cs typeface="Arial" panose="020B0604020202020204" pitchFamily="34" charset="0"/>
                        </a:rPr>
                        <a:t>CTR</a:t>
                      </a: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34" charset="-128"/>
                          <a:cs typeface="Arial" panose="020B0604020202020204" pitchFamily="34" charset="0"/>
                        </a:rPr>
                        <a:t>LC</a:t>
                      </a: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34" charset="-128"/>
                          <a:cs typeface="Arial" panose="020B0604020202020204" pitchFamily="34" charset="0"/>
                        </a:rPr>
                        <a:t>CTR</a:t>
                      </a: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34" charset="-128"/>
                          <a:cs typeface="Arial" panose="020B0604020202020204" pitchFamily="34" charset="0"/>
                        </a:rPr>
                        <a:t>LC</a:t>
                      </a: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90636815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1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6.9 ± 114.7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1.0 ±   66.5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6.1 ± 123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7.3 ±   90.5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4.9 ± 102.0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2.0 ±   91.7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3.4 ± 103.3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6.3 ±   51.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50985872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3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3.4 ± 111.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7.5 ± 111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5.1 ± 121.5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3.0 ±   84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3.6 ± 123.9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6.7 ±   82.8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5.3 ± 114.1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9.7 ± 105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7119345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5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4.0 ± 109.5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9.1 ±   87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3.8 ± 146.8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3.8 ±   76.9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6.7 ± 122.1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4.7 ±   78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6.9 ± 117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6.1 ± 110.8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85755832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7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4.5 ± 116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3.6 ±   90.8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0.8 ± 153.8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4.3 ± 136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3.4 ± 112.3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6.9 ± 130.8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9.2 ± 145.7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8.1 ± 140.0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83168669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9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0.0 ± 131.3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1.0 ±   81.0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8.8 ± 158.9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4.9 ± 129.8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7.1 ± 127.0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4.3 ±   92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3.2 ± 129.9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4.1 ±   86.5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27341503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11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0.0 ± 127.9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5.5 ±   79.0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10.4 ± 160.0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6.1 ±   89.0 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90.8 ± 139.8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7.6 ± 125.0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3.9 ± 142.5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7.1 ±   97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96873738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1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6.7 ± 140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6.7 ± 119.0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25.1 ± 131.8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20.2 ± 169.9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21.9 ± 111.7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10.4 ± 133.3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8.6 ± 148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1.6 ± 119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5897093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2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3.3 ± 110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5.9 ± 130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40.6 ± 162.3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16.1 ± 160.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93.3 ± 114.0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8.8 ± 144.7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9.2 ± 139.7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6.3 ± 140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57149194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3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6.3 ± 131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5.5 ± 118.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91.6 ± 118.0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8.8 ± 137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9.2 ± 134.5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97.4 ± 137.5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5.5 ± 139.0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6.7 ± 156.7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59157734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4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5.3 ± 120.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2.7 ± 123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2.9 ± 134.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4.5 ± 119.5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6.7 ± 147.3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1.8 ± 135.1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97.4 ± 111.1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96.5 ± 154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8274899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5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3.9 ± 129.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5.3 ±   98.8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93.3 ± 132.8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90.0 ±   97.8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3.1 ± 139.0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9.2 ± 103.3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8.8 ± 117.7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0.6 ± 169.5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32435668"/>
                  </a:ext>
                </a:extLst>
              </a:tr>
              <a:tr h="111979">
                <a:tc>
                  <a:txBody>
                    <a:bodyPr/>
                    <a:lstStyle/>
                    <a:p>
                      <a:pPr algn="l" fontAlgn="ctr"/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94187854"/>
                  </a:ext>
                </a:extLst>
              </a:tr>
              <a:tr h="111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34" charset="-128"/>
                          <a:cs typeface="Arial" panose="020B0604020202020204" pitchFamily="34" charset="0"/>
                        </a:rPr>
                        <a:t>24h after</a:t>
                      </a: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34" charset="-128"/>
                          <a:cs typeface="Arial" panose="020B0604020202020204" pitchFamily="34" charset="0"/>
                        </a:rPr>
                        <a:t>CTR</a:t>
                      </a: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34" charset="-128"/>
                          <a:cs typeface="Arial" panose="020B0604020202020204" pitchFamily="34" charset="0"/>
                        </a:rPr>
                        <a:t>LC</a:t>
                      </a: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34" charset="-128"/>
                          <a:cs typeface="Arial" panose="020B0604020202020204" pitchFamily="34" charset="0"/>
                        </a:rPr>
                        <a:t>CTR</a:t>
                      </a: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34" charset="-128"/>
                          <a:cs typeface="Arial" panose="020B0604020202020204" pitchFamily="34" charset="0"/>
                        </a:rPr>
                        <a:t>LC</a:t>
                      </a: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34" charset="-128"/>
                          <a:cs typeface="Arial" panose="020B0604020202020204" pitchFamily="34" charset="0"/>
                        </a:rPr>
                        <a:t>CTR</a:t>
                      </a: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34" charset="-128"/>
                          <a:cs typeface="Arial" panose="020B0604020202020204" pitchFamily="34" charset="0"/>
                        </a:rPr>
                        <a:t>LC</a:t>
                      </a: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34" charset="-128"/>
                          <a:cs typeface="Arial" panose="020B0604020202020204" pitchFamily="34" charset="0"/>
                        </a:rPr>
                        <a:t>CTR</a:t>
                      </a: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34" charset="-128"/>
                          <a:cs typeface="Arial" panose="020B0604020202020204" pitchFamily="34" charset="0"/>
                        </a:rPr>
                        <a:t>LC</a:t>
                      </a: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92034055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1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5.1 ± 112.7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9.7 ± 104.1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8.1 ± 138.7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6.3 ±   50.9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3.6 ± 124.1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4.0 ±   88.7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8.1 ± 129.0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72.0 ±   88.8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7887088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3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0.0 ± 145.8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2.2 ± 112.1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1.4 ± 122.9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4.0 ±   90.9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4.3 ± 124.3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3.4 ±   99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8.1 ± 163.1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75.2 ±   83.1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29778267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5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8.7 ± 137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82.6 ±   91.0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3.8 ± 156.3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8.7 ±   73.0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8.9 ± 134.5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2.0 ±   77.1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1.6 ± 150.1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0.5 ±   85.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6466045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7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1.8 ± 133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7.1 ± 116.5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4.7 ± 147.0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1.2 ± 100.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8.3 ± 112.9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1.2 ± 124.9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8.7 ± 105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3.0 ±   89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98814461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9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8.3 ± 131.3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8.3 ±   73.9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9.0 ± 148.8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7.5 ± 123.7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7.8 ± 147.8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2.8 ±   70.8 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0.0 ± 154.0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5.7 ±   84.1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9538083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11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3.5 ± 161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3.8 ± 109.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3.5 ± 161.5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5.3 ± 144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0.2 ± 125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6.5 ± 139.8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1.4 ± 128.9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4.8 ± 108.0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54854581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1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0.4 ± 110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0.5 ±   93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12.9 ± 143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1.6 ± 117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32.5 ± 159.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0.6 ± 185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5.7 ± 150.8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2.2 ± 142.8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59603943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2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5.5 ± 108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4.0 ± 126.1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95.7 ± 108.0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6.7 ± 122.3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7.2 ± 123.9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0.0 ± 155.1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8.4 ± 133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3.6 ± 124.3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00642872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3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0.6 ± 105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2.6 ± 140.7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8.4 ± 141.5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1.8 ± 122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95.7 ± 111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1.4 ± 133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7.1 ± 125.9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5.7 ± 134.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19627156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4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8.0 ± 123.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6.3 ± 146.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5.3 ± 138.8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4.4 ± 113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9.2 ± 142.0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6.3 ± 129.0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97.4 ± 141.8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3.4 ± 155.3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07872925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5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0.2 ± 104.7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9.6 ± 128.7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3.7 ± 127.3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8.7 ± 122.9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6.7 ± 147.0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4.2 ± 133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96.5 ± 122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8.5 ± 130.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05043556"/>
                  </a:ext>
                </a:extLst>
              </a:tr>
              <a:tr h="111979">
                <a:tc>
                  <a:txBody>
                    <a:bodyPr/>
                    <a:lstStyle/>
                    <a:p>
                      <a:pPr algn="l" fontAlgn="ctr"/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50702741"/>
                  </a:ext>
                </a:extLst>
              </a:tr>
              <a:tr h="111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34" charset="-128"/>
                          <a:cs typeface="Arial" panose="020B0604020202020204" pitchFamily="34" charset="0"/>
                        </a:rPr>
                        <a:t>48h</a:t>
                      </a:r>
                      <a:r>
                        <a:rPr lang="en-US" sz="700" b="1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34" charset="-128"/>
                          <a:cs typeface="Arial" panose="020B0604020202020204" pitchFamily="34" charset="0"/>
                        </a:rPr>
                        <a:t> after</a:t>
                      </a:r>
                      <a:endParaRPr lang="en-US" sz="7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34" charset="-128"/>
                          <a:cs typeface="Arial" panose="020B0604020202020204" pitchFamily="34" charset="0"/>
                        </a:rPr>
                        <a:t>CTR</a:t>
                      </a: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34" charset="-128"/>
                          <a:cs typeface="Arial" panose="020B0604020202020204" pitchFamily="34" charset="0"/>
                        </a:rPr>
                        <a:t>LC</a:t>
                      </a: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34" charset="-128"/>
                          <a:cs typeface="Arial" panose="020B0604020202020204" pitchFamily="34" charset="0"/>
                        </a:rPr>
                        <a:t>CTR</a:t>
                      </a: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34" charset="-128"/>
                          <a:cs typeface="Arial" panose="020B0604020202020204" pitchFamily="34" charset="0"/>
                        </a:rPr>
                        <a:t>LC</a:t>
                      </a: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34" charset="-128"/>
                          <a:cs typeface="Arial" panose="020B0604020202020204" pitchFamily="34" charset="0"/>
                        </a:rPr>
                        <a:t>CTR</a:t>
                      </a: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34" charset="-128"/>
                          <a:cs typeface="Arial" panose="020B0604020202020204" pitchFamily="34" charset="0"/>
                        </a:rPr>
                        <a:t>LC</a:t>
                      </a: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34" charset="-128"/>
                          <a:cs typeface="Arial" panose="020B0604020202020204" pitchFamily="34" charset="0"/>
                        </a:rPr>
                        <a:t>CTR</a:t>
                      </a: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anose="020B0604030504040204" pitchFamily="34" charset="-128"/>
                          <a:cs typeface="Arial" panose="020B0604020202020204" pitchFamily="34" charset="0"/>
                        </a:rPr>
                        <a:t>LC</a:t>
                      </a: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34016754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1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8.1 ± 135.1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1.0 ± 126.1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7.9 ± 116.5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4.0 ± 140.5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1.6 ± 128.7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9.7 ± 149.7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4.2 ± 119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9.3 ± 122.5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24682825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3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9.1 ± 129.0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2.0 ± 135.0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3.9 ± 159.7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6.7 ± 140.9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1.6 ± 126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0.8 ± 170.5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5.1 ± 127.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3.0 ± 118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0520277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5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0.8 ± 133.3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7.1 ± 115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6.9 ± 146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8.9 ± 142.3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9.4 ± 159.1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7.1 ± 145.9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8.7 ± 114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8.1 ± 112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65863030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7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3.6 ± 104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5.9 ± 157.5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9.4 ± 134.0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9.8 ± 127.3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8.5 ± 122.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2.8 ± 145.3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9.2 ± 145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0.0 ± 163.9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41924696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9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0.0 ± 113.9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4.7 ± 128.3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4.7 ± 151.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6.3 ± 165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0.2 ± 158.0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1.4 ± 128.3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5.7 ± 140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8.1 ± 141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23434788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11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7.7 ± 122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1.8 ±   98.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90.0 ± 162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2.0 ± 110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1.2 ± 141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5.1 ± 157.3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4.3 ± 134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5.7 ± 146.9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12522605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1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0.6 ± 119.7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2.8 ± 180.1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37.4 ± 125.3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3.1 ± 157.9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57.8 ± 153.0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8.0 ± 203.8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3.3 ± 112.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3.4 ± 143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80936292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2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5.7 ±   94.3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8.5 ± 188.1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42.3 ± 119.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9.8 ± 177.9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29.2 ± 126.9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8.8 ± 141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0.2 ± 123.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8.5 ± 161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9133508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3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3.9 ± 126.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3.6 ± 160.3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1.8 ± 128.8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3.7 ± 155.1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11.2 ± 119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1.4 ± 163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98.2 ± 130.1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5.3 ± 188.8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2914965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4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12.1 ± 107.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6.7 ± 201.3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97.4 ± 133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1.6 ± 126.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19.4 ± 168.5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5.3 ± 136.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32.5 ± 136.1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1.8 ± 164.1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02296598"/>
                  </a:ext>
                </a:extLst>
              </a:tr>
              <a:tr h="1169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5</a:t>
                      </a:r>
                      <a:endParaRPr lang="en-US" sz="7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ea typeface="Meiryo UI" panose="020B0604030504040204" pitchFamily="34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94.9 ± 140.9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9.8 ± 136.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4.7 ± 125.8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3.5 ± 117.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12.1 ± 123.3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3.5 ± 153.7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30.0 ± 103.9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2.6 ± 152.8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55327936"/>
                  </a:ext>
                </a:extLst>
              </a:tr>
            </a:tbl>
          </a:graphicData>
        </a:graphic>
      </p:graphicFrame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B46A784A-31F7-457C-9C0F-7F436518F9AA}"/>
              </a:ext>
            </a:extLst>
          </p:cNvPr>
          <p:cNvSpPr/>
          <p:nvPr/>
        </p:nvSpPr>
        <p:spPr>
          <a:xfrm>
            <a:off x="142875" y="898530"/>
            <a:ext cx="6007352" cy="2922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r>
              <a:rPr kumimoji="1" lang="en-US" altLang="ja-JP" sz="1100" b="1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upplementary Table 2. PPT values obtained in Figs. 4 and 5 (Experiment </a:t>
            </a:r>
            <a:r>
              <a:rPr lang="en-US" altLang="ja-JP" sz="1100" b="1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2)</a:t>
            </a:r>
            <a:r>
              <a:rPr kumimoji="1" lang="en-US" altLang="ja-JP" sz="1100" b="1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.</a:t>
            </a:r>
            <a:endParaRPr kumimoji="1" lang="ja-JP" altLang="en-US" sz="1100" b="1" dirty="0">
              <a:solidFill>
                <a:schemeClr val="tx1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B46A784A-31F7-457C-9C0F-7F436518F9AA}"/>
              </a:ext>
            </a:extLst>
          </p:cNvPr>
          <p:cNvSpPr/>
          <p:nvPr/>
        </p:nvSpPr>
        <p:spPr>
          <a:xfrm>
            <a:off x="142874" y="6096910"/>
            <a:ext cx="6561175" cy="2922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r>
              <a:rPr kumimoji="1" lang="en-US" altLang="ja-JP" sz="1100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PPTs in kPa are represented as mean ± SD (n = 12 participants each in the CTR and LC groups).</a:t>
            </a:r>
            <a:endParaRPr kumimoji="1" lang="ja-JP" altLang="en-US" sz="1100" dirty="0">
              <a:solidFill>
                <a:schemeClr val="tx1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23216"/>
      </p:ext>
    </p:extLst>
  </p:cSld>
  <p:clrMapOvr>
    <a:masterClrMapping/>
  </p:clrMapOvr>
</p:sld>
</file>

<file path=ppt/theme/theme1.xml><?xml version="1.0" encoding="utf-8"?>
<a:theme xmlns:a="http://schemas.openxmlformats.org/drawingml/2006/main" name="1_標準デザイン">
  <a:themeElements>
    <a:clrScheme name="標準デザイ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標準デザイン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​​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213</TotalTime>
  <Words>908</Words>
  <Application>Microsoft Office PowerPoint</Application>
  <PresentationFormat>A4 210 x 297 mm</PresentationFormat>
  <Paragraphs>33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1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3" baseType="lpstr">
      <vt:lpstr>Arial</vt:lpstr>
      <vt:lpstr>1_標準デザイン</vt:lpstr>
      <vt:lpstr>PowerPoint プレゼンテーション</vt:lpstr>
    </vt:vector>
  </TitlesOfParts>
  <Company>Nagoya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Toru TAGUCHI</dc:creator>
  <cp:lastModifiedBy>田口　徹</cp:lastModifiedBy>
  <cp:revision>1454</cp:revision>
  <cp:lastPrinted>2022-06-19T02:54:35Z</cp:lastPrinted>
  <dcterms:created xsi:type="dcterms:W3CDTF">2011-09-29T08:13:12Z</dcterms:created>
  <dcterms:modified xsi:type="dcterms:W3CDTF">2022-07-12T07:16:22Z</dcterms:modified>
</cp:coreProperties>
</file>